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</p:sldIdLst>
  <p:sldSz cx="6858000" cy="9144000" type="letter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3" pos="480" userDrawn="1">
          <p15:clr>
            <a:srgbClr val="A4A3A4"/>
          </p15:clr>
        </p15:guide>
        <p15:guide id="4" orient="horz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74" autoAdjust="0"/>
    <p:restoredTop sz="94660"/>
  </p:normalViewPr>
  <p:slideViewPr>
    <p:cSldViewPr snapToGrid="0">
      <p:cViewPr>
        <p:scale>
          <a:sx n="75" d="100"/>
          <a:sy n="75" d="100"/>
        </p:scale>
        <p:origin x="3132" y="240"/>
      </p:cViewPr>
      <p:guideLst>
        <p:guide pos="480"/>
        <p:guide orient="horz"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475A9A-C053-4D78-A6CC-10A7FCA02F23}" type="datetimeFigureOut">
              <a:rPr lang="en-US" smtClean="0"/>
              <a:t>7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868DC0-0582-4CF1-9612-D7E113EF6C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58241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475A9A-C053-4D78-A6CC-10A7FCA02F23}" type="datetimeFigureOut">
              <a:rPr lang="en-US" smtClean="0"/>
              <a:t>7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868DC0-0582-4CF1-9612-D7E113EF6C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66469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475A9A-C053-4D78-A6CC-10A7FCA02F23}" type="datetimeFigureOut">
              <a:rPr lang="en-US" smtClean="0"/>
              <a:t>7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868DC0-0582-4CF1-9612-D7E113EF6C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27536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475A9A-C053-4D78-A6CC-10A7FCA02F23}" type="datetimeFigureOut">
              <a:rPr lang="en-US" smtClean="0"/>
              <a:t>7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868DC0-0582-4CF1-9612-D7E113EF6C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51251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475A9A-C053-4D78-A6CC-10A7FCA02F23}" type="datetimeFigureOut">
              <a:rPr lang="en-US" smtClean="0"/>
              <a:t>7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868DC0-0582-4CF1-9612-D7E113EF6C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49434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475A9A-C053-4D78-A6CC-10A7FCA02F23}" type="datetimeFigureOut">
              <a:rPr lang="en-US" smtClean="0"/>
              <a:t>7/2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868DC0-0582-4CF1-9612-D7E113EF6C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19118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475A9A-C053-4D78-A6CC-10A7FCA02F23}" type="datetimeFigureOut">
              <a:rPr lang="en-US" smtClean="0"/>
              <a:t>7/27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868DC0-0582-4CF1-9612-D7E113EF6C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65653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475A9A-C053-4D78-A6CC-10A7FCA02F23}" type="datetimeFigureOut">
              <a:rPr lang="en-US" smtClean="0"/>
              <a:t>7/27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868DC0-0582-4CF1-9612-D7E113EF6C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90943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475A9A-C053-4D78-A6CC-10A7FCA02F23}" type="datetimeFigureOut">
              <a:rPr lang="en-US" smtClean="0"/>
              <a:t>7/27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868DC0-0582-4CF1-9612-D7E113EF6C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60366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475A9A-C053-4D78-A6CC-10A7FCA02F23}" type="datetimeFigureOut">
              <a:rPr lang="en-US" smtClean="0"/>
              <a:t>7/2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868DC0-0582-4CF1-9612-D7E113EF6C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348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475A9A-C053-4D78-A6CC-10A7FCA02F23}" type="datetimeFigureOut">
              <a:rPr lang="en-US" smtClean="0"/>
              <a:t>7/2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868DC0-0582-4CF1-9612-D7E113EF6C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61389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475A9A-C053-4D78-A6CC-10A7FCA02F23}" type="datetimeFigureOut">
              <a:rPr lang="en-US" smtClean="0"/>
              <a:t>7/2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868DC0-0582-4CF1-9612-D7E113EF6C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40276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>
            <a:extLst>
              <a:ext uri="{FF2B5EF4-FFF2-40B4-BE49-F238E27FC236}">
                <a16:creationId xmlns:a16="http://schemas.microsoft.com/office/drawing/2014/main" id="{7AAF6917-F811-400A-9CE4-F5A2495ADE39}"/>
              </a:ext>
            </a:extLst>
          </p:cNvPr>
          <p:cNvGrpSpPr/>
          <p:nvPr/>
        </p:nvGrpSpPr>
        <p:grpSpPr>
          <a:xfrm>
            <a:off x="1131995" y="361528"/>
            <a:ext cx="3837119" cy="1838709"/>
            <a:chOff x="1131995" y="484838"/>
            <a:chExt cx="3837119" cy="1838709"/>
          </a:xfrm>
        </p:grpSpPr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91288943-91DA-4208-B035-726E1C8452CF}"/>
                </a:ext>
              </a:extLst>
            </p:cNvPr>
            <p:cNvSpPr txBox="1"/>
            <p:nvPr/>
          </p:nvSpPr>
          <p:spPr>
            <a:xfrm rot="18828417">
              <a:off x="935899" y="1248508"/>
              <a:ext cx="18351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Total tissue exact (T)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30EA1A85-FE0E-4CCF-849A-3BC7DA373A9D}"/>
                </a:ext>
              </a:extLst>
            </p:cNvPr>
            <p:cNvSpPr txBox="1"/>
            <p:nvPr/>
          </p:nvSpPr>
          <p:spPr>
            <a:xfrm rot="18828417">
              <a:off x="1262180" y="1335826"/>
              <a:ext cx="155889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Cytoplasmic (C)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65ABF406-16CF-4BB1-A0AC-990F554A07F8}"/>
                </a:ext>
              </a:extLst>
            </p:cNvPr>
            <p:cNvSpPr txBox="1"/>
            <p:nvPr/>
          </p:nvSpPr>
          <p:spPr>
            <a:xfrm rot="18828417">
              <a:off x="1612036" y="1485691"/>
              <a:ext cx="109998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Nuclear (N)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1C9C26F1-97F0-4247-A1D1-B9698C2AD1B6}"/>
                </a:ext>
              </a:extLst>
            </p:cNvPr>
            <p:cNvSpPr txBox="1"/>
            <p:nvPr/>
          </p:nvSpPr>
          <p:spPr>
            <a:xfrm rot="18828417">
              <a:off x="1835173" y="1397984"/>
              <a:ext cx="13564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Membrane (M)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FE8121C9-B3EE-41DF-AC5C-E989F6800681}"/>
                </a:ext>
              </a:extLst>
            </p:cNvPr>
            <p:cNvSpPr txBox="1"/>
            <p:nvPr/>
          </p:nvSpPr>
          <p:spPr>
            <a:xfrm rot="18828417">
              <a:off x="2047534" y="1307209"/>
              <a:ext cx="163859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Cytoskeleton (CS)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6A1A9094-B5DF-4067-91E9-CB06E94C29AD}"/>
                </a:ext>
              </a:extLst>
            </p:cNvPr>
            <p:cNvSpPr txBox="1"/>
            <p:nvPr/>
          </p:nvSpPr>
          <p:spPr>
            <a:xfrm rot="18828417">
              <a:off x="775167" y="1519859"/>
              <a:ext cx="102143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ECM (E)   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36FB022F-1F56-44CE-832F-3E635223DE3C}"/>
                </a:ext>
              </a:extLst>
            </p:cNvPr>
            <p:cNvSpPr txBox="1"/>
            <p:nvPr/>
          </p:nvSpPr>
          <p:spPr>
            <a:xfrm rot="18828417">
              <a:off x="3524514" y="1488560"/>
              <a:ext cx="109998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Nuclear (N)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987FF75C-9523-480D-952D-2C33307B8A5D}"/>
                </a:ext>
              </a:extLst>
            </p:cNvPr>
            <p:cNvSpPr txBox="1"/>
            <p:nvPr/>
          </p:nvSpPr>
          <p:spPr>
            <a:xfrm rot="18828417">
              <a:off x="3756799" y="1397985"/>
              <a:ext cx="13564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Membrane (M)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5CF328A2-117E-4A3F-AB38-676270E13609}"/>
                </a:ext>
              </a:extLst>
            </p:cNvPr>
            <p:cNvSpPr txBox="1"/>
            <p:nvPr/>
          </p:nvSpPr>
          <p:spPr>
            <a:xfrm rot="18828417">
              <a:off x="3995931" y="1305185"/>
              <a:ext cx="163859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Cytoskeleton (CS)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0E78E0F9-3E16-49A7-BD65-89B8011787A4}"/>
                </a:ext>
              </a:extLst>
            </p:cNvPr>
            <p:cNvSpPr txBox="1"/>
            <p:nvPr/>
          </p:nvSpPr>
          <p:spPr>
            <a:xfrm rot="18828417">
              <a:off x="2684857" y="1514931"/>
              <a:ext cx="102143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ECM (E)   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8859F88F-35CB-4336-B05F-BC153E3F4E27}"/>
                </a:ext>
              </a:extLst>
            </p:cNvPr>
            <p:cNvSpPr txBox="1"/>
            <p:nvPr/>
          </p:nvSpPr>
          <p:spPr>
            <a:xfrm rot="18828417">
              <a:off x="2825077" y="1252099"/>
              <a:ext cx="18351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Total tissue exact (T)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30EA1A85-FE0E-4CCF-849A-3BC7DA373A9D}"/>
                </a:ext>
              </a:extLst>
            </p:cNvPr>
            <p:cNvSpPr txBox="1"/>
            <p:nvPr/>
          </p:nvSpPr>
          <p:spPr>
            <a:xfrm rot="18828417">
              <a:off x="3148812" y="1339926"/>
              <a:ext cx="155889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Cytoplasmic (C)</a:t>
              </a:r>
            </a:p>
          </p:txBody>
        </p:sp>
      </p:grpSp>
      <p:sp>
        <p:nvSpPr>
          <p:cNvPr id="116" name="TextBox 115"/>
          <p:cNvSpPr txBox="1"/>
          <p:nvPr/>
        </p:nvSpPr>
        <p:spPr>
          <a:xfrm>
            <a:off x="343307" y="1970488"/>
            <a:ext cx="4720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7" name="TextBox 116"/>
          <p:cNvSpPr txBox="1"/>
          <p:nvPr/>
        </p:nvSpPr>
        <p:spPr>
          <a:xfrm>
            <a:off x="343307" y="5230839"/>
            <a:ext cx="4720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19" name="Group 18">
            <a:extLst>
              <a:ext uri="{FF2B5EF4-FFF2-40B4-BE49-F238E27FC236}">
                <a16:creationId xmlns:a16="http://schemas.microsoft.com/office/drawing/2014/main" id="{692FEE69-AE54-42A2-9247-6CC30AFD0808}"/>
              </a:ext>
            </a:extLst>
          </p:cNvPr>
          <p:cNvGrpSpPr/>
          <p:nvPr/>
        </p:nvGrpSpPr>
        <p:grpSpPr>
          <a:xfrm>
            <a:off x="669697" y="5251821"/>
            <a:ext cx="3916756" cy="339489"/>
            <a:chOff x="669697" y="5001770"/>
            <a:chExt cx="3916756" cy="339489"/>
          </a:xfrm>
        </p:grpSpPr>
        <p:cxnSp>
          <p:nvCxnSpPr>
            <p:cNvPr id="112" name="Straight Connector 111">
              <a:extLst>
                <a:ext uri="{FF2B5EF4-FFF2-40B4-BE49-F238E27FC236}">
                  <a16:creationId xmlns:a16="http://schemas.microsoft.com/office/drawing/2014/main" id="{20F7BC06-53B3-4DD1-9564-BC048F9392A8}"/>
                </a:ext>
              </a:extLst>
            </p:cNvPr>
            <p:cNvCxnSpPr>
              <a:cxnSpLocks/>
            </p:cNvCxnSpPr>
            <p:nvPr/>
          </p:nvCxnSpPr>
          <p:spPr>
            <a:xfrm>
              <a:off x="783219" y="5341259"/>
              <a:ext cx="1817106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A8BF785C-A8A4-4436-8FFC-CE47C8C4C0B7}"/>
                </a:ext>
              </a:extLst>
            </p:cNvPr>
            <p:cNvSpPr txBox="1"/>
            <p:nvPr/>
          </p:nvSpPr>
          <p:spPr>
            <a:xfrm>
              <a:off x="669697" y="5001770"/>
              <a:ext cx="204414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L05 – Matched Normal </a:t>
              </a: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ACE3B296-8C69-4DF5-820E-883C868552EF}"/>
                </a:ext>
              </a:extLst>
            </p:cNvPr>
            <p:cNvSpPr txBox="1"/>
            <p:nvPr/>
          </p:nvSpPr>
          <p:spPr>
            <a:xfrm>
              <a:off x="3084627" y="5004354"/>
              <a:ext cx="11878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L05 – Tumor</a:t>
              </a:r>
            </a:p>
          </p:txBody>
        </p:sp>
        <p:cxnSp>
          <p:nvCxnSpPr>
            <p:cNvPr id="122" name="Straight Connector 121">
              <a:extLst>
                <a:ext uri="{FF2B5EF4-FFF2-40B4-BE49-F238E27FC236}">
                  <a16:creationId xmlns:a16="http://schemas.microsoft.com/office/drawing/2014/main" id="{20F7BC06-53B3-4DD1-9564-BC048F9392A8}"/>
                </a:ext>
              </a:extLst>
            </p:cNvPr>
            <p:cNvCxnSpPr>
              <a:cxnSpLocks/>
            </p:cNvCxnSpPr>
            <p:nvPr/>
          </p:nvCxnSpPr>
          <p:spPr>
            <a:xfrm>
              <a:off x="2780128" y="5341259"/>
              <a:ext cx="1806325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2" name="Picture 1">
            <a:extLst>
              <a:ext uri="{FF2B5EF4-FFF2-40B4-BE49-F238E27FC236}">
                <a16:creationId xmlns:a16="http://schemas.microsoft.com/office/drawing/2014/main" id="{5F2BBA63-6845-4FEE-9FF0-27DABDCD385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3219" y="2651461"/>
            <a:ext cx="3809411" cy="2462743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790B64CD-F0D7-4DD2-A852-EED41958BBC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83219" y="5905224"/>
            <a:ext cx="3808274" cy="3038320"/>
          </a:xfrm>
          <a:prstGeom prst="rect">
            <a:avLst/>
          </a:prstGeom>
        </p:spPr>
      </p:pic>
      <p:grpSp>
        <p:nvGrpSpPr>
          <p:cNvPr id="20" name="Group 19">
            <a:extLst>
              <a:ext uri="{FF2B5EF4-FFF2-40B4-BE49-F238E27FC236}">
                <a16:creationId xmlns:a16="http://schemas.microsoft.com/office/drawing/2014/main" id="{49ED170C-6A10-4738-8A27-5E43C4A304F0}"/>
              </a:ext>
            </a:extLst>
          </p:cNvPr>
          <p:cNvGrpSpPr/>
          <p:nvPr/>
        </p:nvGrpSpPr>
        <p:grpSpPr>
          <a:xfrm>
            <a:off x="4645943" y="2689927"/>
            <a:ext cx="1606772" cy="2310369"/>
            <a:chOff x="4645943" y="1995219"/>
            <a:chExt cx="1606772" cy="2310369"/>
          </a:xfrm>
        </p:grpSpPr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A77E3C74-E1DF-4B70-B47F-8F4B1D5CF7FF}"/>
                </a:ext>
              </a:extLst>
            </p:cNvPr>
            <p:cNvSpPr txBox="1"/>
            <p:nvPr/>
          </p:nvSpPr>
          <p:spPr>
            <a:xfrm>
              <a:off x="4824119" y="2138018"/>
              <a:ext cx="14285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Collagen I (E)   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C678003F-8F4F-4F92-B200-DDC90B09ADE5}"/>
                </a:ext>
              </a:extLst>
            </p:cNvPr>
            <p:cNvSpPr txBox="1"/>
            <p:nvPr/>
          </p:nvSpPr>
          <p:spPr>
            <a:xfrm>
              <a:off x="4827807" y="2650604"/>
              <a:ext cx="13404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4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1 integrin (M)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AC799F5F-8F5C-45BC-B3FD-396A0D332C3F}"/>
                </a:ext>
              </a:extLst>
            </p:cNvPr>
            <p:cNvSpPr txBox="1"/>
            <p:nvPr/>
          </p:nvSpPr>
          <p:spPr>
            <a:xfrm>
              <a:off x="4824119" y="3082463"/>
              <a:ext cx="133716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hnRNP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 H1 (N)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3CD4A3D6-CC74-4D46-940A-9CF088070ABF}"/>
                </a:ext>
              </a:extLst>
            </p:cNvPr>
            <p:cNvSpPr txBox="1"/>
            <p:nvPr/>
          </p:nvSpPr>
          <p:spPr>
            <a:xfrm>
              <a:off x="4824119" y="3565312"/>
              <a:ext cx="112242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GAPDH (C)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80ECBE88-AB72-4619-AFA5-D98A617304A2}"/>
                </a:ext>
              </a:extLst>
            </p:cNvPr>
            <p:cNvSpPr txBox="1"/>
            <p:nvPr/>
          </p:nvSpPr>
          <p:spPr>
            <a:xfrm>
              <a:off x="4824119" y="3997811"/>
              <a:ext cx="100219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Actin (CS)</a:t>
              </a:r>
            </a:p>
          </p:txBody>
        </p:sp>
        <p:cxnSp>
          <p:nvCxnSpPr>
            <p:cNvPr id="5" name="Straight Arrow Connector 4">
              <a:extLst>
                <a:ext uri="{FF2B5EF4-FFF2-40B4-BE49-F238E27FC236}">
                  <a16:creationId xmlns:a16="http://schemas.microsoft.com/office/drawing/2014/main" id="{D29A899B-1690-46E1-A5FB-55CCF15B4AE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645943" y="2820945"/>
              <a:ext cx="18288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Straight Arrow Connector 60">
              <a:extLst>
                <a:ext uri="{FF2B5EF4-FFF2-40B4-BE49-F238E27FC236}">
                  <a16:creationId xmlns:a16="http://schemas.microsoft.com/office/drawing/2014/main" id="{E96ADACE-21C4-4B4D-8325-339BA68ADDF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645943" y="3256038"/>
              <a:ext cx="18288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Straight Arrow Connector 61">
              <a:extLst>
                <a:ext uri="{FF2B5EF4-FFF2-40B4-BE49-F238E27FC236}">
                  <a16:creationId xmlns:a16="http://schemas.microsoft.com/office/drawing/2014/main" id="{CA296102-5FC3-46F9-8098-BD6B3240D96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645943" y="3732259"/>
              <a:ext cx="18288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Straight Arrow Connector 62">
              <a:extLst>
                <a:ext uri="{FF2B5EF4-FFF2-40B4-BE49-F238E27FC236}">
                  <a16:creationId xmlns:a16="http://schemas.microsoft.com/office/drawing/2014/main" id="{E945A5C4-B01C-4BCE-89FD-037915142BD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645943" y="4166667"/>
              <a:ext cx="18288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Right Brace 6">
              <a:extLst>
                <a:ext uri="{FF2B5EF4-FFF2-40B4-BE49-F238E27FC236}">
                  <a16:creationId xmlns:a16="http://schemas.microsoft.com/office/drawing/2014/main" id="{D9862CCE-19BE-43B9-9896-E620DB8EE872}"/>
                </a:ext>
              </a:extLst>
            </p:cNvPr>
            <p:cNvSpPr/>
            <p:nvPr/>
          </p:nvSpPr>
          <p:spPr>
            <a:xfrm>
              <a:off x="4645943" y="1995219"/>
              <a:ext cx="106321" cy="624153"/>
            </a:xfrm>
            <a:prstGeom prst="rightBrac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</p:grpSp>
      <p:grpSp>
        <p:nvGrpSpPr>
          <p:cNvPr id="18" name="Group 17">
            <a:extLst>
              <a:ext uri="{FF2B5EF4-FFF2-40B4-BE49-F238E27FC236}">
                <a16:creationId xmlns:a16="http://schemas.microsoft.com/office/drawing/2014/main" id="{8CD76ADB-582A-4220-9E15-124BBA039281}"/>
              </a:ext>
            </a:extLst>
          </p:cNvPr>
          <p:cNvGrpSpPr/>
          <p:nvPr/>
        </p:nvGrpSpPr>
        <p:grpSpPr>
          <a:xfrm>
            <a:off x="4645943" y="5962328"/>
            <a:ext cx="1606772" cy="2834244"/>
            <a:chOff x="4645943" y="5481369"/>
            <a:chExt cx="1606772" cy="2834244"/>
          </a:xfrm>
        </p:grpSpPr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0BD15D65-8E3E-4F9A-809C-E99AE3573384}"/>
                </a:ext>
              </a:extLst>
            </p:cNvPr>
            <p:cNvSpPr txBox="1"/>
            <p:nvPr/>
          </p:nvSpPr>
          <p:spPr>
            <a:xfrm>
              <a:off x="4824119" y="5757518"/>
              <a:ext cx="14285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Collagen I (E)   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55D589FE-D70A-469C-80DF-6806A532B1FB}"/>
                </a:ext>
              </a:extLst>
            </p:cNvPr>
            <p:cNvSpPr txBox="1"/>
            <p:nvPr/>
          </p:nvSpPr>
          <p:spPr>
            <a:xfrm>
              <a:off x="4827807" y="6470129"/>
              <a:ext cx="13404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4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1 integrin (M)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2B81DE32-8F70-4F20-AD16-0DF21CFD8290}"/>
                </a:ext>
              </a:extLst>
            </p:cNvPr>
            <p:cNvSpPr txBox="1"/>
            <p:nvPr/>
          </p:nvSpPr>
          <p:spPr>
            <a:xfrm>
              <a:off x="4824119" y="7063913"/>
              <a:ext cx="133716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hnRNP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 H1 (N)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20E8A403-B2E8-4008-B0C5-5F50B871CA3C}"/>
                </a:ext>
              </a:extLst>
            </p:cNvPr>
            <p:cNvSpPr txBox="1"/>
            <p:nvPr/>
          </p:nvSpPr>
          <p:spPr>
            <a:xfrm>
              <a:off x="4824119" y="7461037"/>
              <a:ext cx="112242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GAPDH (C)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05C3F45C-6282-4700-A49B-54F4EA883E87}"/>
                </a:ext>
              </a:extLst>
            </p:cNvPr>
            <p:cNvSpPr txBox="1"/>
            <p:nvPr/>
          </p:nvSpPr>
          <p:spPr>
            <a:xfrm>
              <a:off x="4824119" y="8007836"/>
              <a:ext cx="100219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Actin (CS)</a:t>
              </a:r>
            </a:p>
          </p:txBody>
        </p:sp>
        <p:cxnSp>
          <p:nvCxnSpPr>
            <p:cNvPr id="76" name="Straight Arrow Connector 75">
              <a:extLst>
                <a:ext uri="{FF2B5EF4-FFF2-40B4-BE49-F238E27FC236}">
                  <a16:creationId xmlns:a16="http://schemas.microsoft.com/office/drawing/2014/main" id="{1C00F31C-166D-4810-89F6-4A2D5290209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645943" y="6640470"/>
              <a:ext cx="18288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Straight Arrow Connector 76">
              <a:extLst>
                <a:ext uri="{FF2B5EF4-FFF2-40B4-BE49-F238E27FC236}">
                  <a16:creationId xmlns:a16="http://schemas.microsoft.com/office/drawing/2014/main" id="{ADBA8068-C8B4-4731-905C-C66C7721BFF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645943" y="7237488"/>
              <a:ext cx="18288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Straight Arrow Connector 77">
              <a:extLst>
                <a:ext uri="{FF2B5EF4-FFF2-40B4-BE49-F238E27FC236}">
                  <a16:creationId xmlns:a16="http://schemas.microsoft.com/office/drawing/2014/main" id="{97DE2C4F-5E41-49C4-9BFF-6F5B729856F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645943" y="7627984"/>
              <a:ext cx="18288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Straight Arrow Connector 78">
              <a:extLst>
                <a:ext uri="{FF2B5EF4-FFF2-40B4-BE49-F238E27FC236}">
                  <a16:creationId xmlns:a16="http://schemas.microsoft.com/office/drawing/2014/main" id="{CE577845-73ED-49EA-B50C-3E8D9CB1B9D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645943" y="8176692"/>
              <a:ext cx="18288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Right Brace 79">
              <a:extLst>
                <a:ext uri="{FF2B5EF4-FFF2-40B4-BE49-F238E27FC236}">
                  <a16:creationId xmlns:a16="http://schemas.microsoft.com/office/drawing/2014/main" id="{BC2AE90C-73BA-477C-86C5-E9B325CAAE3C}"/>
                </a:ext>
              </a:extLst>
            </p:cNvPr>
            <p:cNvSpPr/>
            <p:nvPr/>
          </p:nvSpPr>
          <p:spPr>
            <a:xfrm>
              <a:off x="4645943" y="5481369"/>
              <a:ext cx="106321" cy="888077"/>
            </a:xfrm>
            <a:prstGeom prst="rightBrac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</p:grpSp>
      <p:grpSp>
        <p:nvGrpSpPr>
          <p:cNvPr id="81" name="Group 80">
            <a:extLst>
              <a:ext uri="{FF2B5EF4-FFF2-40B4-BE49-F238E27FC236}">
                <a16:creationId xmlns:a16="http://schemas.microsoft.com/office/drawing/2014/main" id="{4201907E-3B8C-4630-BB79-15064988BFED}"/>
              </a:ext>
            </a:extLst>
          </p:cNvPr>
          <p:cNvGrpSpPr/>
          <p:nvPr/>
        </p:nvGrpSpPr>
        <p:grpSpPr>
          <a:xfrm>
            <a:off x="701460" y="1985877"/>
            <a:ext cx="3891907" cy="339489"/>
            <a:chOff x="694546" y="5001770"/>
            <a:chExt cx="3891907" cy="339489"/>
          </a:xfrm>
        </p:grpSpPr>
        <p:cxnSp>
          <p:nvCxnSpPr>
            <p:cNvPr id="82" name="Straight Connector 81">
              <a:extLst>
                <a:ext uri="{FF2B5EF4-FFF2-40B4-BE49-F238E27FC236}">
                  <a16:creationId xmlns:a16="http://schemas.microsoft.com/office/drawing/2014/main" id="{3189CD69-B04B-4279-AD53-3AE0503F3096}"/>
                </a:ext>
              </a:extLst>
            </p:cNvPr>
            <p:cNvCxnSpPr>
              <a:cxnSpLocks/>
            </p:cNvCxnSpPr>
            <p:nvPr/>
          </p:nvCxnSpPr>
          <p:spPr>
            <a:xfrm>
              <a:off x="783219" y="5341259"/>
              <a:ext cx="1817106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C8732CA2-2A55-4B61-A5B3-1424AF8F4F7A}"/>
                </a:ext>
              </a:extLst>
            </p:cNvPr>
            <p:cNvSpPr txBox="1"/>
            <p:nvPr/>
          </p:nvSpPr>
          <p:spPr>
            <a:xfrm>
              <a:off x="694546" y="5001770"/>
              <a:ext cx="19944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L01 – Matched Normal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CE2E2A35-07AD-4B9E-AED7-6D785603A444}"/>
                </a:ext>
              </a:extLst>
            </p:cNvPr>
            <p:cNvSpPr txBox="1"/>
            <p:nvPr/>
          </p:nvSpPr>
          <p:spPr>
            <a:xfrm>
              <a:off x="3084628" y="5004354"/>
              <a:ext cx="118782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L01 – Tumor</a:t>
              </a:r>
            </a:p>
          </p:txBody>
        </p:sp>
        <p:cxnSp>
          <p:nvCxnSpPr>
            <p:cNvPr id="85" name="Straight Connector 84">
              <a:extLst>
                <a:ext uri="{FF2B5EF4-FFF2-40B4-BE49-F238E27FC236}">
                  <a16:creationId xmlns:a16="http://schemas.microsoft.com/office/drawing/2014/main" id="{B5EC4309-E705-4775-9F7D-2A3A5F810D9A}"/>
                </a:ext>
              </a:extLst>
            </p:cNvPr>
            <p:cNvCxnSpPr>
              <a:cxnSpLocks/>
            </p:cNvCxnSpPr>
            <p:nvPr/>
          </p:nvCxnSpPr>
          <p:spPr>
            <a:xfrm>
              <a:off x="2780128" y="5341259"/>
              <a:ext cx="1806325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6" name="TextBox 55">
            <a:extLst>
              <a:ext uri="{FF2B5EF4-FFF2-40B4-BE49-F238E27FC236}">
                <a16:creationId xmlns:a16="http://schemas.microsoft.com/office/drawing/2014/main" id="{36D511B0-BD73-4109-AA98-58A04783E02F}"/>
              </a:ext>
            </a:extLst>
          </p:cNvPr>
          <p:cNvSpPr txBox="1"/>
          <p:nvPr/>
        </p:nvSpPr>
        <p:spPr>
          <a:xfrm>
            <a:off x="214293" y="223858"/>
            <a:ext cx="440871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sz="2000" b="1">
                <a:latin typeface="Arial" panose="020B0604020202020204" pitchFamily="34" charset="0"/>
                <a:cs typeface="Arial" panose="020B0604020202020204" pitchFamily="34" charset="0"/>
              </a:rPr>
              <a:t>Figure S1 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DC2E039E-77CD-4FD1-81AC-5D9F7693C693}"/>
              </a:ext>
            </a:extLst>
          </p:cNvPr>
          <p:cNvGrpSpPr/>
          <p:nvPr/>
        </p:nvGrpSpPr>
        <p:grpSpPr>
          <a:xfrm>
            <a:off x="868661" y="2346923"/>
            <a:ext cx="1826316" cy="307777"/>
            <a:chOff x="868661" y="2216298"/>
            <a:chExt cx="1826316" cy="307777"/>
          </a:xfrm>
        </p:grpSpPr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A2B1C4CE-14C7-4575-963D-8B15E64C0FAD}"/>
                </a:ext>
              </a:extLst>
            </p:cNvPr>
            <p:cNvSpPr txBox="1"/>
            <p:nvPr/>
          </p:nvSpPr>
          <p:spPr>
            <a:xfrm>
              <a:off x="868661" y="2216298"/>
              <a:ext cx="3276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1366DACA-8DC2-4832-B57C-41559CFF722F}"/>
                </a:ext>
              </a:extLst>
            </p:cNvPr>
            <p:cNvSpPr txBox="1"/>
            <p:nvPr/>
          </p:nvSpPr>
          <p:spPr>
            <a:xfrm>
              <a:off x="1067143" y="2216298"/>
              <a:ext cx="5181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CD213056-F755-47EF-84E0-53640EC062CA}"/>
                </a:ext>
              </a:extLst>
            </p:cNvPr>
            <p:cNvSpPr txBox="1"/>
            <p:nvPr/>
          </p:nvSpPr>
          <p:spPr>
            <a:xfrm>
              <a:off x="1352889" y="2216298"/>
              <a:ext cx="5181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BC5F0164-AF05-4E45-8CF8-55A1062EB293}"/>
                </a:ext>
              </a:extLst>
            </p:cNvPr>
            <p:cNvSpPr txBox="1"/>
            <p:nvPr/>
          </p:nvSpPr>
          <p:spPr>
            <a:xfrm>
              <a:off x="1616146" y="2216298"/>
              <a:ext cx="5181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A7E4B3CF-25B2-4FD5-90B0-5E7AED82A9B7}"/>
                </a:ext>
              </a:extLst>
            </p:cNvPr>
            <p:cNvSpPr txBox="1"/>
            <p:nvPr/>
          </p:nvSpPr>
          <p:spPr>
            <a:xfrm>
              <a:off x="1897724" y="2216298"/>
              <a:ext cx="5181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5F29749C-8CFA-4901-A90F-9DFF5535D4E1}"/>
                </a:ext>
              </a:extLst>
            </p:cNvPr>
            <p:cNvSpPr txBox="1"/>
            <p:nvPr/>
          </p:nvSpPr>
          <p:spPr>
            <a:xfrm>
              <a:off x="2176798" y="2216298"/>
              <a:ext cx="5181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CS</a:t>
              </a:r>
            </a:p>
          </p:txBody>
        </p:sp>
      </p:grpSp>
      <p:grpSp>
        <p:nvGrpSpPr>
          <p:cNvPr id="72" name="Group 71">
            <a:extLst>
              <a:ext uri="{FF2B5EF4-FFF2-40B4-BE49-F238E27FC236}">
                <a16:creationId xmlns:a16="http://schemas.microsoft.com/office/drawing/2014/main" id="{9974BBBE-A971-4CDC-85A8-2D138690B3D0}"/>
              </a:ext>
            </a:extLst>
          </p:cNvPr>
          <p:cNvGrpSpPr/>
          <p:nvPr/>
        </p:nvGrpSpPr>
        <p:grpSpPr>
          <a:xfrm>
            <a:off x="2772297" y="2347638"/>
            <a:ext cx="1826316" cy="307777"/>
            <a:chOff x="868661" y="2216298"/>
            <a:chExt cx="1826316" cy="307777"/>
          </a:xfrm>
        </p:grpSpPr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2E2062FD-65F2-49CC-97CC-F9F93BAAC27D}"/>
                </a:ext>
              </a:extLst>
            </p:cNvPr>
            <p:cNvSpPr txBox="1"/>
            <p:nvPr/>
          </p:nvSpPr>
          <p:spPr>
            <a:xfrm>
              <a:off x="868661" y="2216298"/>
              <a:ext cx="3276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1629EB41-5D9A-4304-B5F6-8944C281923D}"/>
                </a:ext>
              </a:extLst>
            </p:cNvPr>
            <p:cNvSpPr txBox="1"/>
            <p:nvPr/>
          </p:nvSpPr>
          <p:spPr>
            <a:xfrm>
              <a:off x="1067143" y="2216298"/>
              <a:ext cx="5181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3E7ADE40-BEB0-4250-8D78-967FFEB3DB02}"/>
                </a:ext>
              </a:extLst>
            </p:cNvPr>
            <p:cNvSpPr txBox="1"/>
            <p:nvPr/>
          </p:nvSpPr>
          <p:spPr>
            <a:xfrm>
              <a:off x="1352889" y="2216298"/>
              <a:ext cx="5181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C7F972BA-E601-41AF-8E08-72DC8634BA97}"/>
                </a:ext>
              </a:extLst>
            </p:cNvPr>
            <p:cNvSpPr txBox="1"/>
            <p:nvPr/>
          </p:nvSpPr>
          <p:spPr>
            <a:xfrm>
              <a:off x="1616146" y="2216298"/>
              <a:ext cx="5181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2B7F7BD6-2CFC-4191-B5FA-46C61AB370C8}"/>
                </a:ext>
              </a:extLst>
            </p:cNvPr>
            <p:cNvSpPr txBox="1"/>
            <p:nvPr/>
          </p:nvSpPr>
          <p:spPr>
            <a:xfrm>
              <a:off x="1897724" y="2216298"/>
              <a:ext cx="5181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EFE279FA-7EAB-4F7E-8E44-459B94ADB50C}"/>
                </a:ext>
              </a:extLst>
            </p:cNvPr>
            <p:cNvSpPr txBox="1"/>
            <p:nvPr/>
          </p:nvSpPr>
          <p:spPr>
            <a:xfrm>
              <a:off x="2176798" y="2216298"/>
              <a:ext cx="5181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CS</a:t>
              </a:r>
            </a:p>
          </p:txBody>
        </p:sp>
      </p:grpSp>
      <p:grpSp>
        <p:nvGrpSpPr>
          <p:cNvPr id="91" name="Group 90">
            <a:extLst>
              <a:ext uri="{FF2B5EF4-FFF2-40B4-BE49-F238E27FC236}">
                <a16:creationId xmlns:a16="http://schemas.microsoft.com/office/drawing/2014/main" id="{0829BE3F-A5BD-4DE1-818C-75A70BB34559}"/>
              </a:ext>
            </a:extLst>
          </p:cNvPr>
          <p:cNvGrpSpPr/>
          <p:nvPr/>
        </p:nvGrpSpPr>
        <p:grpSpPr>
          <a:xfrm>
            <a:off x="778613" y="5600799"/>
            <a:ext cx="1826316" cy="307777"/>
            <a:chOff x="868661" y="2216298"/>
            <a:chExt cx="1826316" cy="307777"/>
          </a:xfrm>
        </p:grpSpPr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108459F5-E54F-4193-8EB4-FB05611A0565}"/>
                </a:ext>
              </a:extLst>
            </p:cNvPr>
            <p:cNvSpPr txBox="1"/>
            <p:nvPr/>
          </p:nvSpPr>
          <p:spPr>
            <a:xfrm>
              <a:off x="868661" y="2216298"/>
              <a:ext cx="3276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D519B930-2A17-4CA0-B1B8-5B497845A4DF}"/>
                </a:ext>
              </a:extLst>
            </p:cNvPr>
            <p:cNvSpPr txBox="1"/>
            <p:nvPr/>
          </p:nvSpPr>
          <p:spPr>
            <a:xfrm>
              <a:off x="1067143" y="2216298"/>
              <a:ext cx="5181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F0B0A0D5-0669-495B-8E7B-737B47A87A59}"/>
                </a:ext>
              </a:extLst>
            </p:cNvPr>
            <p:cNvSpPr txBox="1"/>
            <p:nvPr/>
          </p:nvSpPr>
          <p:spPr>
            <a:xfrm>
              <a:off x="1352889" y="2216298"/>
              <a:ext cx="5181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E9B56FC2-B74D-41A2-9E59-87E32B178336}"/>
                </a:ext>
              </a:extLst>
            </p:cNvPr>
            <p:cNvSpPr txBox="1"/>
            <p:nvPr/>
          </p:nvSpPr>
          <p:spPr>
            <a:xfrm>
              <a:off x="1616146" y="2216298"/>
              <a:ext cx="5181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BB271028-CF98-4852-B211-D9FA9D842AF1}"/>
                </a:ext>
              </a:extLst>
            </p:cNvPr>
            <p:cNvSpPr txBox="1"/>
            <p:nvPr/>
          </p:nvSpPr>
          <p:spPr>
            <a:xfrm>
              <a:off x="1897724" y="2216298"/>
              <a:ext cx="5181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390F0AB1-FE29-4E2B-BA55-542CEEB7B6DB}"/>
                </a:ext>
              </a:extLst>
            </p:cNvPr>
            <p:cNvSpPr txBox="1"/>
            <p:nvPr/>
          </p:nvSpPr>
          <p:spPr>
            <a:xfrm>
              <a:off x="2176798" y="2216298"/>
              <a:ext cx="5181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CS</a:t>
              </a:r>
            </a:p>
          </p:txBody>
        </p:sp>
      </p:grpSp>
      <p:grpSp>
        <p:nvGrpSpPr>
          <p:cNvPr id="98" name="Group 97">
            <a:extLst>
              <a:ext uri="{FF2B5EF4-FFF2-40B4-BE49-F238E27FC236}">
                <a16:creationId xmlns:a16="http://schemas.microsoft.com/office/drawing/2014/main" id="{A2B52A10-83A3-4D75-B45D-21924D6CF093}"/>
              </a:ext>
            </a:extLst>
          </p:cNvPr>
          <p:cNvGrpSpPr/>
          <p:nvPr/>
        </p:nvGrpSpPr>
        <p:grpSpPr>
          <a:xfrm>
            <a:off x="2791833" y="5597447"/>
            <a:ext cx="1826316" cy="307777"/>
            <a:chOff x="868661" y="2216298"/>
            <a:chExt cx="1826316" cy="307777"/>
          </a:xfrm>
        </p:grpSpPr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8A348530-55AF-48D2-B78B-EB238AA636F1}"/>
                </a:ext>
              </a:extLst>
            </p:cNvPr>
            <p:cNvSpPr txBox="1"/>
            <p:nvPr/>
          </p:nvSpPr>
          <p:spPr>
            <a:xfrm>
              <a:off x="868661" y="2216298"/>
              <a:ext cx="3276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D2704A44-8F0F-45E3-9CBE-86307179C17D}"/>
                </a:ext>
              </a:extLst>
            </p:cNvPr>
            <p:cNvSpPr txBox="1"/>
            <p:nvPr/>
          </p:nvSpPr>
          <p:spPr>
            <a:xfrm>
              <a:off x="1067143" y="2216298"/>
              <a:ext cx="5181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13FF4DE5-CF21-4121-813E-55C1AC49A08C}"/>
                </a:ext>
              </a:extLst>
            </p:cNvPr>
            <p:cNvSpPr txBox="1"/>
            <p:nvPr/>
          </p:nvSpPr>
          <p:spPr>
            <a:xfrm>
              <a:off x="1352889" y="2216298"/>
              <a:ext cx="5181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40DFCF7B-4C6A-4A17-86F1-A86EA036CD20}"/>
                </a:ext>
              </a:extLst>
            </p:cNvPr>
            <p:cNvSpPr txBox="1"/>
            <p:nvPr/>
          </p:nvSpPr>
          <p:spPr>
            <a:xfrm>
              <a:off x="1616146" y="2216298"/>
              <a:ext cx="5181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31E3FA8C-1CB1-4D16-A6B1-363326A87F76}"/>
                </a:ext>
              </a:extLst>
            </p:cNvPr>
            <p:cNvSpPr txBox="1"/>
            <p:nvPr/>
          </p:nvSpPr>
          <p:spPr>
            <a:xfrm>
              <a:off x="1897724" y="2216298"/>
              <a:ext cx="5181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</p:txBody>
        </p: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0F2E885C-01CC-4A75-9A6C-0A399401A7FA}"/>
                </a:ext>
              </a:extLst>
            </p:cNvPr>
            <p:cNvSpPr txBox="1"/>
            <p:nvPr/>
          </p:nvSpPr>
          <p:spPr>
            <a:xfrm>
              <a:off x="2176798" y="2216298"/>
              <a:ext cx="5181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CS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6588390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35</TotalTime>
  <Words>143</Words>
  <Application>Microsoft Office PowerPoint</Application>
  <PresentationFormat>Letter Paper (8.5x11 in)</PresentationFormat>
  <Paragraphs>5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CSS</dc:creator>
  <cp:lastModifiedBy>Joanna Bons</cp:lastModifiedBy>
  <cp:revision>28</cp:revision>
  <cp:lastPrinted>2022-06-23T17:18:58Z</cp:lastPrinted>
  <dcterms:created xsi:type="dcterms:W3CDTF">2022-06-21T22:07:57Z</dcterms:created>
  <dcterms:modified xsi:type="dcterms:W3CDTF">2022-07-27T22:03:41Z</dcterms:modified>
</cp:coreProperties>
</file>